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73" d="100"/>
          <a:sy n="73" d="100"/>
        </p:scale>
        <p:origin x="9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9734;&#9675;&#9675;&#65374;&#65374;\&#12385;&#12423;&#12371;&#12387;&#12392;\&#35542;&#25991;\3_indole%20lactic%20acid%20&#29987;&#29983;\ILA_IAld_IAA_IP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04196530580522E-2"/>
          <c:y val="4.7297298908233698E-2"/>
          <c:w val="0.89820414781570401"/>
          <c:h val="0.743243217468262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FF00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E202-41C4-B020-2A30059F4E4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E202-41C4-B020-2A30059F4E47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E202-41C4-B020-2A30059F4E47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E202-41C4-B020-2A30059F4E47}"/>
              </c:ext>
            </c:extLst>
          </c:dPt>
          <c:dPt>
            <c:idx val="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E202-41C4-B020-2A30059F4E47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E202-41C4-B020-2A30059F4E47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E202-41C4-B020-2A30059F4E47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E202-41C4-B020-2A30059F4E47}"/>
              </c:ext>
            </c:extLst>
          </c:dPt>
          <c:dPt>
            <c:idx val="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E202-41C4-B020-2A30059F4E47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E202-41C4-B020-2A30059F4E47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E202-41C4-B020-2A30059F4E47}"/>
              </c:ext>
            </c:extLst>
          </c:dPt>
          <c:dPt>
            <c:idx val="1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E202-41C4-B020-2A30059F4E47}"/>
              </c:ext>
            </c:extLst>
          </c:dPt>
          <c:dPt>
            <c:idx val="12"/>
            <c:invertIfNegative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E202-41C4-B020-2A30059F4E47}"/>
              </c:ext>
            </c:extLst>
          </c:dPt>
          <c:dPt>
            <c:idx val="1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E202-41C4-B020-2A30059F4E47}"/>
              </c:ext>
            </c:extLst>
          </c:dPt>
          <c:dPt>
            <c:idx val="1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E202-41C4-B020-2A30059F4E47}"/>
              </c:ext>
            </c:extLst>
          </c:dPt>
          <c:dPt>
            <c:idx val="1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E202-41C4-B020-2A30059F4E47}"/>
              </c:ext>
            </c:extLst>
          </c:dPt>
          <c:dPt>
            <c:idx val="16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1-E202-41C4-B020-2A30059F4E47}"/>
              </c:ext>
            </c:extLst>
          </c:dPt>
          <c:dPt>
            <c:idx val="1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3-E202-41C4-B020-2A30059F4E47}"/>
              </c:ext>
            </c:extLst>
          </c:dPt>
          <c:dPt>
            <c:idx val="18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5-E202-41C4-B020-2A30059F4E47}"/>
              </c:ext>
            </c:extLst>
          </c:dPt>
          <c:dPt>
            <c:idx val="1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7-E202-41C4-B020-2A30059F4E47}"/>
              </c:ext>
            </c:extLst>
          </c:dPt>
          <c:dPt>
            <c:idx val="20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9-E202-41C4-B020-2A30059F4E47}"/>
              </c:ext>
            </c:extLst>
          </c:dPt>
          <c:dPt>
            <c:idx val="2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B-E202-41C4-B020-2A30059F4E47}"/>
              </c:ext>
            </c:extLst>
          </c:dPt>
          <c:dPt>
            <c:idx val="2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D-E202-41C4-B020-2A30059F4E47}"/>
              </c:ext>
            </c:extLst>
          </c:dPt>
          <c:dPt>
            <c:idx val="23"/>
            <c:invertIfNegative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F-E202-41C4-B020-2A30059F4E47}"/>
              </c:ext>
            </c:extLst>
          </c:dPt>
          <c:dPt>
            <c:idx val="2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1-E202-41C4-B020-2A30059F4E47}"/>
              </c:ext>
            </c:extLst>
          </c:dPt>
          <c:dPt>
            <c:idx val="2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3-E202-41C4-B020-2A30059F4E47}"/>
              </c:ext>
            </c:extLst>
          </c:dPt>
          <c:dPt>
            <c:idx val="2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5-E202-41C4-B020-2A30059F4E47}"/>
              </c:ext>
            </c:extLst>
          </c:dPt>
          <c:dPt>
            <c:idx val="2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7-E202-41C4-B020-2A30059F4E47}"/>
              </c:ext>
            </c:extLst>
          </c:dPt>
          <c:dPt>
            <c:idx val="2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9-E202-41C4-B020-2A30059F4E47}"/>
              </c:ext>
            </c:extLst>
          </c:dPt>
          <c:dPt>
            <c:idx val="2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B-E202-41C4-B020-2A30059F4E47}"/>
              </c:ext>
            </c:extLst>
          </c:dPt>
          <c:dPt>
            <c:idx val="3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D-E202-41C4-B020-2A30059F4E47}"/>
              </c:ext>
            </c:extLst>
          </c:dPt>
          <c:dPt>
            <c:idx val="31"/>
            <c:invertIfNegative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F-E202-41C4-B020-2A30059F4E47}"/>
              </c:ext>
            </c:extLst>
          </c:dPt>
          <c:dPt>
            <c:idx val="32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1-E202-41C4-B020-2A30059F4E47}"/>
              </c:ext>
            </c:extLst>
          </c:dPt>
          <c:dPt>
            <c:idx val="3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3-E202-41C4-B020-2A30059F4E47}"/>
              </c:ext>
            </c:extLst>
          </c:dPt>
          <c:dPt>
            <c:idx val="3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5-E202-41C4-B020-2A30059F4E47}"/>
              </c:ext>
            </c:extLst>
          </c:dPt>
          <c:dPt>
            <c:idx val="3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7-E202-41C4-B020-2A30059F4E47}"/>
              </c:ext>
            </c:extLst>
          </c:dPt>
          <c:dPt>
            <c:idx val="3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9-E202-41C4-B020-2A30059F4E47}"/>
              </c:ext>
            </c:extLst>
          </c:dPt>
          <c:dPt>
            <c:idx val="37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B-E202-41C4-B020-2A30059F4E47}"/>
              </c:ext>
            </c:extLst>
          </c:dPt>
          <c:dPt>
            <c:idx val="38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D-E202-41C4-B020-2A30059F4E47}"/>
              </c:ext>
            </c:extLst>
          </c:dPt>
          <c:dPt>
            <c:idx val="3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F-E202-41C4-B020-2A30059F4E47}"/>
              </c:ext>
            </c:extLst>
          </c:dPt>
          <c:dPt>
            <c:idx val="40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1-E202-41C4-B020-2A30059F4E47}"/>
              </c:ext>
            </c:extLst>
          </c:dPt>
          <c:dPt>
            <c:idx val="4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3-E202-41C4-B020-2A30059F4E47}"/>
              </c:ext>
            </c:extLst>
          </c:dPt>
          <c:dPt>
            <c:idx val="4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5-E202-41C4-B020-2A30059F4E47}"/>
              </c:ext>
            </c:extLst>
          </c:dPt>
          <c:dPt>
            <c:idx val="4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7-E202-41C4-B020-2A30059F4E47}"/>
              </c:ext>
            </c:extLst>
          </c:dPt>
          <c:dPt>
            <c:idx val="4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9-E202-41C4-B020-2A30059F4E47}"/>
              </c:ext>
            </c:extLst>
          </c:dPt>
          <c:dPt>
            <c:idx val="4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B-E202-41C4-B020-2A30059F4E47}"/>
              </c:ext>
            </c:extLst>
          </c:dPt>
          <c:dPt>
            <c:idx val="46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D-E202-41C4-B020-2A30059F4E47}"/>
              </c:ext>
            </c:extLst>
          </c:dPt>
          <c:dPt>
            <c:idx val="47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F-E202-41C4-B020-2A30059F4E47}"/>
              </c:ext>
            </c:extLst>
          </c:dPt>
          <c:dPt>
            <c:idx val="4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61-E202-41C4-B020-2A30059F4E47}"/>
              </c:ext>
            </c:extLst>
          </c:dPt>
          <c:dPt>
            <c:idx val="49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63-E202-41C4-B020-2A30059F4E47}"/>
              </c:ext>
            </c:extLst>
          </c:dPt>
          <c:cat>
            <c:strRef>
              <c:f>'風呂 100 株'!$F$4:$F$53</c:f>
              <c:strCache>
                <c:ptCount val="50"/>
                <c:pt idx="0">
                  <c:v>1M05</c:v>
                </c:pt>
                <c:pt idx="1">
                  <c:v>2F02</c:v>
                </c:pt>
                <c:pt idx="2">
                  <c:v>1B04</c:v>
                </c:pt>
                <c:pt idx="3">
                  <c:v>1F01</c:v>
                </c:pt>
                <c:pt idx="4">
                  <c:v>3F01</c:v>
                </c:pt>
                <c:pt idx="5">
                  <c:v>3M01</c:v>
                </c:pt>
                <c:pt idx="6">
                  <c:v>1B01</c:v>
                </c:pt>
                <c:pt idx="7">
                  <c:v>1M02</c:v>
                </c:pt>
                <c:pt idx="8">
                  <c:v>3S2-03</c:v>
                </c:pt>
                <c:pt idx="9">
                  <c:v>2M01</c:v>
                </c:pt>
                <c:pt idx="10">
                  <c:v>2B03</c:v>
                </c:pt>
                <c:pt idx="11">
                  <c:v>1D06</c:v>
                </c:pt>
                <c:pt idx="12">
                  <c:v>1D05</c:v>
                </c:pt>
                <c:pt idx="13">
                  <c:v>2F03</c:v>
                </c:pt>
                <c:pt idx="14">
                  <c:v>1S01</c:v>
                </c:pt>
                <c:pt idx="15">
                  <c:v>2M03</c:v>
                </c:pt>
                <c:pt idx="16">
                  <c:v>1B02</c:v>
                </c:pt>
                <c:pt idx="17">
                  <c:v>1D07</c:v>
                </c:pt>
                <c:pt idx="18">
                  <c:v>1D04</c:v>
                </c:pt>
                <c:pt idx="19">
                  <c:v>2S01</c:v>
                </c:pt>
                <c:pt idx="20">
                  <c:v>1F04</c:v>
                </c:pt>
                <c:pt idx="21">
                  <c:v>1M06</c:v>
                </c:pt>
                <c:pt idx="22">
                  <c:v>5M03</c:v>
                </c:pt>
                <c:pt idx="23">
                  <c:v>2S02</c:v>
                </c:pt>
                <c:pt idx="24">
                  <c:v>1S05</c:v>
                </c:pt>
                <c:pt idx="25">
                  <c:v>5F04</c:v>
                </c:pt>
                <c:pt idx="26">
                  <c:v>2S03</c:v>
                </c:pt>
                <c:pt idx="27">
                  <c:v>4F01</c:v>
                </c:pt>
                <c:pt idx="28">
                  <c:v>2F01</c:v>
                </c:pt>
                <c:pt idx="29">
                  <c:v>4M02</c:v>
                </c:pt>
                <c:pt idx="30">
                  <c:v>2D01</c:v>
                </c:pt>
                <c:pt idx="31">
                  <c:v>1S03</c:v>
                </c:pt>
                <c:pt idx="32">
                  <c:v>2D03</c:v>
                </c:pt>
                <c:pt idx="33">
                  <c:v>4F04</c:v>
                </c:pt>
                <c:pt idx="34">
                  <c:v>5B02</c:v>
                </c:pt>
                <c:pt idx="35">
                  <c:v>3M03</c:v>
                </c:pt>
                <c:pt idx="36">
                  <c:v>2F04</c:v>
                </c:pt>
                <c:pt idx="37">
                  <c:v>3F04</c:v>
                </c:pt>
                <c:pt idx="38">
                  <c:v>5D03</c:v>
                </c:pt>
                <c:pt idx="39">
                  <c:v>3F05</c:v>
                </c:pt>
                <c:pt idx="40">
                  <c:v>5B05</c:v>
                </c:pt>
                <c:pt idx="41">
                  <c:v>4S04</c:v>
                </c:pt>
                <c:pt idx="42">
                  <c:v>4B01</c:v>
                </c:pt>
                <c:pt idx="43">
                  <c:v>4D01</c:v>
                </c:pt>
                <c:pt idx="44">
                  <c:v>3S1-02</c:v>
                </c:pt>
                <c:pt idx="45">
                  <c:v>5D01</c:v>
                </c:pt>
                <c:pt idx="46">
                  <c:v>5M01</c:v>
                </c:pt>
                <c:pt idx="47">
                  <c:v>3S1-01</c:v>
                </c:pt>
                <c:pt idx="48">
                  <c:v>4D04</c:v>
                </c:pt>
                <c:pt idx="49">
                  <c:v>4F03</c:v>
                </c:pt>
              </c:strCache>
            </c:strRef>
          </c:cat>
          <c:val>
            <c:numRef>
              <c:f>'風呂 100 株'!$H$4:$H$53</c:f>
              <c:numCache>
                <c:formatCode>0.00</c:formatCode>
                <c:ptCount val="50"/>
                <c:pt idx="0">
                  <c:v>0.46196528760170064</c:v>
                </c:pt>
                <c:pt idx="1">
                  <c:v>0.36671392974121225</c:v>
                </c:pt>
                <c:pt idx="2">
                  <c:v>0.3334607747805185</c:v>
                </c:pt>
                <c:pt idx="3">
                  <c:v>0.27339880383471166</c:v>
                </c:pt>
                <c:pt idx="4">
                  <c:v>0.27114567430145919</c:v>
                </c:pt>
                <c:pt idx="5">
                  <c:v>0.26940026061203554</c:v>
                </c:pt>
                <c:pt idx="6">
                  <c:v>0.25752321901786585</c:v>
                </c:pt>
                <c:pt idx="7">
                  <c:v>0.24837350230039207</c:v>
                </c:pt>
                <c:pt idx="8">
                  <c:v>0.232713227917385</c:v>
                </c:pt>
                <c:pt idx="9">
                  <c:v>0.23045306666349738</c:v>
                </c:pt>
                <c:pt idx="10">
                  <c:v>0.22535642400120937</c:v>
                </c:pt>
                <c:pt idx="11">
                  <c:v>0.22061253628800925</c:v>
                </c:pt>
                <c:pt idx="12">
                  <c:v>0.21594049531958431</c:v>
                </c:pt>
                <c:pt idx="13">
                  <c:v>0.21350020405279008</c:v>
                </c:pt>
                <c:pt idx="14">
                  <c:v>0.21265664267087686</c:v>
                </c:pt>
                <c:pt idx="15">
                  <c:v>0.2067718697808037</c:v>
                </c:pt>
                <c:pt idx="16">
                  <c:v>0.20367989570589351</c:v>
                </c:pt>
                <c:pt idx="17">
                  <c:v>0.19508093545560279</c:v>
                </c:pt>
                <c:pt idx="18">
                  <c:v>0.18688029655736141</c:v>
                </c:pt>
                <c:pt idx="19">
                  <c:v>0.17585754927718492</c:v>
                </c:pt>
                <c:pt idx="20">
                  <c:v>0.17347949028241094</c:v>
                </c:pt>
                <c:pt idx="21">
                  <c:v>0.17316767442244932</c:v>
                </c:pt>
                <c:pt idx="22">
                  <c:v>0.16120579792279638</c:v>
                </c:pt>
                <c:pt idx="23">
                  <c:v>0.14783297867219353</c:v>
                </c:pt>
                <c:pt idx="24">
                  <c:v>0.13944317429847192</c:v>
                </c:pt>
                <c:pt idx="25">
                  <c:v>0.12814938029030898</c:v>
                </c:pt>
                <c:pt idx="26">
                  <c:v>0.12661187432287213</c:v>
                </c:pt>
                <c:pt idx="27">
                  <c:v>0.10328921741483989</c:v>
                </c:pt>
                <c:pt idx="28">
                  <c:v>9.6658386024900317E-2</c:v>
                </c:pt>
                <c:pt idx="29">
                  <c:v>9.5269276651752249E-2</c:v>
                </c:pt>
                <c:pt idx="30">
                  <c:v>8.9043153286864241E-2</c:v>
                </c:pt>
                <c:pt idx="31">
                  <c:v>8.7556590517064992E-2</c:v>
                </c:pt>
                <c:pt idx="32">
                  <c:v>8.3461079768224464E-2</c:v>
                </c:pt>
                <c:pt idx="33">
                  <c:v>7.7667134381309746E-2</c:v>
                </c:pt>
                <c:pt idx="34">
                  <c:v>7.4591563783655015E-2</c:v>
                </c:pt>
                <c:pt idx="35">
                  <c:v>6.6219518630789051E-2</c:v>
                </c:pt>
                <c:pt idx="36">
                  <c:v>5.9961954152926912E-2</c:v>
                </c:pt>
                <c:pt idx="37">
                  <c:v>5.4905069771229428E-2</c:v>
                </c:pt>
                <c:pt idx="38">
                  <c:v>5.3059099179794865E-2</c:v>
                </c:pt>
                <c:pt idx="39">
                  <c:v>4.5653856198272127E-2</c:v>
                </c:pt>
                <c:pt idx="40">
                  <c:v>4.3217108123628716E-2</c:v>
                </c:pt>
                <c:pt idx="41">
                  <c:v>4.1786877012122914E-2</c:v>
                </c:pt>
                <c:pt idx="42">
                  <c:v>3.5232989027669179E-2</c:v>
                </c:pt>
                <c:pt idx="43">
                  <c:v>3.2338919177744813E-2</c:v>
                </c:pt>
                <c:pt idx="44">
                  <c:v>2.1573399512360002E-2</c:v>
                </c:pt>
                <c:pt idx="45">
                  <c:v>0</c:v>
                </c:pt>
                <c:pt idx="46">
                  <c:v>0</c:v>
                </c:pt>
                <c:pt idx="47">
                  <c:v>-8.0111020138591005E-3</c:v>
                </c:pt>
                <c:pt idx="48">
                  <c:v>-4.8906470405075501E-2</c:v>
                </c:pt>
                <c:pt idx="49">
                  <c:v>-7.79537248197443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4-E202-41C4-B020-2A30059F4E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424163880"/>
        <c:axId val="424387592"/>
      </c:barChart>
      <c:catAx>
        <c:axId val="424163880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200" b="1" i="0">
                    <a:solidFill>
                      <a:schemeClr val="tx1"/>
                    </a:solidFill>
                    <a:latin typeface="Arial Narrow"/>
                  </a:defRPr>
                </a:pPr>
                <a:r>
                  <a:rPr lang="ko-KR" altLang="en-US" dirty="0" smtClean="0"/>
                  <a:t>Sample No.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48300737142562883"/>
              <c:y val="0.9052192568778995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16200000" vert="horz"/>
          <a:lstStyle/>
          <a:p>
            <a:pPr>
              <a:defRPr sz="900" b="1" i="0">
                <a:solidFill>
                  <a:schemeClr val="tx1"/>
                </a:solidFill>
                <a:latin typeface="Arial Narrow"/>
              </a:defRPr>
            </a:pPr>
            <a:endParaRPr lang="ja-JP"/>
          </a:p>
        </c:txPr>
        <c:crossAx val="424387592"/>
        <c:crosses val="autoZero"/>
        <c:auto val="1"/>
        <c:lblAlgn val="ctr"/>
        <c:lblOffset val="100"/>
        <c:tickMarkSkip val="1"/>
        <c:noMultiLvlLbl val="0"/>
      </c:catAx>
      <c:valAx>
        <c:axId val="424387592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16200000" vert="horz"/>
              <a:lstStyle/>
              <a:p>
                <a:pPr>
                  <a:defRPr sz="1200" b="1" i="0">
                    <a:solidFill>
                      <a:schemeClr val="tx1"/>
                    </a:solidFill>
                    <a:latin typeface="Arial Narrow"/>
                  </a:defRPr>
                </a:pPr>
                <a:r>
                  <a:rPr lang="ko-KR" altLang="en-US" dirty="0" smtClean="0"/>
                  <a:t>ILA (μg/ml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247329730540514E-2"/>
              <c:y val="0.34789305925369268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/>
          <a:lstStyle/>
          <a:p>
            <a:pPr>
              <a:defRPr sz="1100" b="1" i="0">
                <a:solidFill>
                  <a:schemeClr val="tx1"/>
                </a:solidFill>
                <a:latin typeface="Arial Narrow"/>
              </a:defRPr>
            </a:pPr>
            <a:endParaRPr lang="ja-JP"/>
          </a:p>
        </c:txPr>
        <c:crossAx val="424163880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1"/>
  </c:chart>
  <c:spPr>
    <a:solidFill>
      <a:schemeClr val="bg1"/>
    </a:solidFill>
    <a:ln w="254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extLst>
    <c:ext uri="CC8EB2C9-7E31-499d-B8F2-F6CE61031016">
      <ho:hncChartStyle xmlns:ho="http://schemas.haansoft.com/office/8.0" layoutIndex="-1" colorIndex="-1" styleIndex="-1"/>
    </c:ext>
  </c:extLst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784435898065567E-2"/>
          <c:y val="4.7297298908233698E-2"/>
          <c:w val="0.89940172433853161"/>
          <c:h val="0.74324321746826205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rgbClr val="FF0000"/>
            </a:solidFill>
            <a:ln w="952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91A-4320-813B-8549DEF2B70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91A-4320-813B-8549DEF2B70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91A-4320-813B-8549DEF2B703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91A-4320-813B-8549DEF2B70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91A-4320-813B-8549DEF2B703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91A-4320-813B-8549DEF2B703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91A-4320-813B-8549DEF2B703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91A-4320-813B-8549DEF2B703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691A-4320-813B-8549DEF2B703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691A-4320-813B-8549DEF2B703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691A-4320-813B-8549DEF2B703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691A-4320-813B-8549DEF2B703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691A-4320-813B-8549DEF2B703}"/>
              </c:ext>
            </c:extLst>
          </c:dPt>
          <c:dPt>
            <c:idx val="13"/>
            <c:invertIfNegative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691A-4320-813B-8549DEF2B703}"/>
              </c:ext>
            </c:extLst>
          </c:dPt>
          <c:dPt>
            <c:idx val="1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691A-4320-813B-8549DEF2B703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691A-4320-813B-8549DEF2B703}"/>
              </c:ext>
            </c:extLst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1-691A-4320-813B-8549DEF2B703}"/>
              </c:ext>
            </c:extLst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3-691A-4320-813B-8549DEF2B703}"/>
              </c:ext>
            </c:extLst>
          </c:dPt>
          <c:dPt>
            <c:idx val="18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5-691A-4320-813B-8549DEF2B703}"/>
              </c:ext>
            </c:extLst>
          </c:dPt>
          <c:dPt>
            <c:idx val="19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7-691A-4320-813B-8549DEF2B703}"/>
              </c:ext>
            </c:extLst>
          </c:dPt>
          <c:dPt>
            <c:idx val="2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9-691A-4320-813B-8549DEF2B703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B-691A-4320-813B-8549DEF2B703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D-691A-4320-813B-8549DEF2B703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2F-691A-4320-813B-8549DEF2B703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1-691A-4320-813B-8549DEF2B703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3-691A-4320-813B-8549DEF2B703}"/>
              </c:ext>
            </c:extLst>
          </c:dPt>
          <c:dPt>
            <c:idx val="2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5-691A-4320-813B-8549DEF2B703}"/>
              </c:ext>
            </c:extLst>
          </c:dPt>
          <c:dPt>
            <c:idx val="27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7-691A-4320-813B-8549DEF2B703}"/>
              </c:ext>
            </c:extLst>
          </c:dPt>
          <c:dPt>
            <c:idx val="2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9-691A-4320-813B-8549DEF2B703}"/>
              </c:ext>
            </c:extLst>
          </c:dPt>
          <c:dPt>
            <c:idx val="29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B-691A-4320-813B-8549DEF2B703}"/>
              </c:ext>
            </c:extLst>
          </c:dPt>
          <c:dPt>
            <c:idx val="30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D-691A-4320-813B-8549DEF2B703}"/>
              </c:ext>
            </c:extLst>
          </c:dPt>
          <c:dPt>
            <c:idx val="31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3F-691A-4320-813B-8549DEF2B703}"/>
              </c:ext>
            </c:extLst>
          </c:dPt>
          <c:dPt>
            <c:idx val="32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1-691A-4320-813B-8549DEF2B703}"/>
              </c:ext>
            </c:extLst>
          </c:dPt>
          <c:dPt>
            <c:idx val="33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3-691A-4320-813B-8549DEF2B703}"/>
              </c:ext>
            </c:extLst>
          </c:dPt>
          <c:dPt>
            <c:idx val="34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5-691A-4320-813B-8549DEF2B703}"/>
              </c:ext>
            </c:extLst>
          </c:dPt>
          <c:dPt>
            <c:idx val="35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7-691A-4320-813B-8549DEF2B703}"/>
              </c:ext>
            </c:extLst>
          </c:dPt>
          <c:dPt>
            <c:idx val="3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9-691A-4320-813B-8549DEF2B703}"/>
              </c:ext>
            </c:extLst>
          </c:dPt>
          <c:dPt>
            <c:idx val="3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B-691A-4320-813B-8549DEF2B703}"/>
              </c:ext>
            </c:extLst>
          </c:dPt>
          <c:dPt>
            <c:idx val="38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D-691A-4320-813B-8549DEF2B703}"/>
              </c:ext>
            </c:extLst>
          </c:dPt>
          <c:dPt>
            <c:idx val="39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4F-691A-4320-813B-8549DEF2B703}"/>
              </c:ext>
            </c:extLst>
          </c:dPt>
          <c:dPt>
            <c:idx val="40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1-691A-4320-813B-8549DEF2B703}"/>
              </c:ext>
            </c:extLst>
          </c:dPt>
          <c:dPt>
            <c:idx val="41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3-691A-4320-813B-8549DEF2B703}"/>
              </c:ext>
            </c:extLst>
          </c:dPt>
          <c:dPt>
            <c:idx val="4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5-691A-4320-813B-8549DEF2B703}"/>
              </c:ext>
            </c:extLst>
          </c:dPt>
          <c:dPt>
            <c:idx val="43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7-691A-4320-813B-8549DEF2B703}"/>
              </c:ext>
            </c:extLst>
          </c:dPt>
          <c:dPt>
            <c:idx val="4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9-691A-4320-813B-8549DEF2B703}"/>
              </c:ext>
            </c:extLst>
          </c:dPt>
          <c:dPt>
            <c:idx val="45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B-691A-4320-813B-8549DEF2B703}"/>
              </c:ext>
            </c:extLst>
          </c:dPt>
          <c:dPt>
            <c:idx val="46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D-691A-4320-813B-8549DEF2B703}"/>
              </c:ext>
            </c:extLst>
          </c:dPt>
          <c:dPt>
            <c:idx val="47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5F-691A-4320-813B-8549DEF2B703}"/>
              </c:ext>
            </c:extLst>
          </c:dPt>
          <c:dPt>
            <c:idx val="48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61-691A-4320-813B-8549DEF2B703}"/>
              </c:ext>
            </c:extLst>
          </c:dPt>
          <c:dPt>
            <c:idx val="49"/>
            <c:invertIfNegative val="0"/>
            <c:bubble3D val="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63-691A-4320-813B-8549DEF2B703}"/>
              </c:ext>
            </c:extLst>
          </c:dPt>
          <c:cat>
            <c:strRef>
              <c:f>'風呂 100 株'!$B$4:$B$53</c:f>
              <c:strCache>
                <c:ptCount val="50"/>
                <c:pt idx="0">
                  <c:v>2B04</c:v>
                </c:pt>
                <c:pt idx="1">
                  <c:v>4S01</c:v>
                </c:pt>
                <c:pt idx="2">
                  <c:v>2M04</c:v>
                </c:pt>
                <c:pt idx="3">
                  <c:v>3B02</c:v>
                </c:pt>
                <c:pt idx="4">
                  <c:v>1S04</c:v>
                </c:pt>
                <c:pt idx="5">
                  <c:v>2D02</c:v>
                </c:pt>
                <c:pt idx="6">
                  <c:v>2S04</c:v>
                </c:pt>
                <c:pt idx="7">
                  <c:v>2M02</c:v>
                </c:pt>
                <c:pt idx="8">
                  <c:v>1M04</c:v>
                </c:pt>
                <c:pt idx="9">
                  <c:v>3B01</c:v>
                </c:pt>
                <c:pt idx="10">
                  <c:v>1F03</c:v>
                </c:pt>
                <c:pt idx="11">
                  <c:v>5B01</c:v>
                </c:pt>
                <c:pt idx="12">
                  <c:v>5B03</c:v>
                </c:pt>
                <c:pt idx="13">
                  <c:v>1M01</c:v>
                </c:pt>
                <c:pt idx="14">
                  <c:v>2B01</c:v>
                </c:pt>
                <c:pt idx="15">
                  <c:v>5D05</c:v>
                </c:pt>
                <c:pt idx="16">
                  <c:v>1D02</c:v>
                </c:pt>
                <c:pt idx="17">
                  <c:v>3F02</c:v>
                </c:pt>
                <c:pt idx="18">
                  <c:v>3S2-01</c:v>
                </c:pt>
                <c:pt idx="19">
                  <c:v>3F03</c:v>
                </c:pt>
                <c:pt idx="20">
                  <c:v>4B04</c:v>
                </c:pt>
                <c:pt idx="21">
                  <c:v>5F03</c:v>
                </c:pt>
                <c:pt idx="22">
                  <c:v>1M03</c:v>
                </c:pt>
                <c:pt idx="23">
                  <c:v>4F02</c:v>
                </c:pt>
                <c:pt idx="24">
                  <c:v>5D02</c:v>
                </c:pt>
                <c:pt idx="25">
                  <c:v>1B03</c:v>
                </c:pt>
                <c:pt idx="26">
                  <c:v>5F01</c:v>
                </c:pt>
                <c:pt idx="27">
                  <c:v>5M02</c:v>
                </c:pt>
                <c:pt idx="28">
                  <c:v>4S02</c:v>
                </c:pt>
                <c:pt idx="29">
                  <c:v>4B02</c:v>
                </c:pt>
                <c:pt idx="30">
                  <c:v>1M05</c:v>
                </c:pt>
                <c:pt idx="31">
                  <c:v>1D01</c:v>
                </c:pt>
                <c:pt idx="32">
                  <c:v>4M03</c:v>
                </c:pt>
                <c:pt idx="33">
                  <c:v>5S01</c:v>
                </c:pt>
                <c:pt idx="34">
                  <c:v>4S03</c:v>
                </c:pt>
                <c:pt idx="35">
                  <c:v>4D02</c:v>
                </c:pt>
                <c:pt idx="36">
                  <c:v>3D01</c:v>
                </c:pt>
                <c:pt idx="37">
                  <c:v>5S02</c:v>
                </c:pt>
                <c:pt idx="38">
                  <c:v>1F02</c:v>
                </c:pt>
                <c:pt idx="39">
                  <c:v>2B02</c:v>
                </c:pt>
                <c:pt idx="40">
                  <c:v>1S02</c:v>
                </c:pt>
                <c:pt idx="41">
                  <c:v>3M02</c:v>
                </c:pt>
                <c:pt idx="42">
                  <c:v>1D03</c:v>
                </c:pt>
                <c:pt idx="43">
                  <c:v>3S2-02</c:v>
                </c:pt>
                <c:pt idx="44">
                  <c:v>5D04</c:v>
                </c:pt>
                <c:pt idx="45">
                  <c:v>5F02</c:v>
                </c:pt>
                <c:pt idx="46">
                  <c:v>4B03</c:v>
                </c:pt>
                <c:pt idx="47">
                  <c:v>4D03</c:v>
                </c:pt>
                <c:pt idx="48">
                  <c:v>4M01</c:v>
                </c:pt>
                <c:pt idx="49">
                  <c:v>5B04</c:v>
                </c:pt>
              </c:strCache>
            </c:strRef>
          </c:cat>
          <c:val>
            <c:numRef>
              <c:f>'風呂 100 株'!$D$4:$D$53</c:f>
              <c:numCache>
                <c:formatCode>0.00</c:formatCode>
                <c:ptCount val="50"/>
                <c:pt idx="0">
                  <c:v>4.9170079879984581</c:v>
                </c:pt>
                <c:pt idx="1">
                  <c:v>4.0176299998163723</c:v>
                </c:pt>
                <c:pt idx="2">
                  <c:v>3.8462443837057987</c:v>
                </c:pt>
                <c:pt idx="3">
                  <c:v>3.7087144897658781</c:v>
                </c:pt>
                <c:pt idx="4">
                  <c:v>3.4050033262935657</c:v>
                </c:pt>
                <c:pt idx="5">
                  <c:v>3.1135957020071063</c:v>
                </c:pt>
                <c:pt idx="6">
                  <c:v>3.0270371816428221</c:v>
                </c:pt>
                <c:pt idx="7">
                  <c:v>2.9728801898158239</c:v>
                </c:pt>
                <c:pt idx="8">
                  <c:v>2.9187988267562837</c:v>
                </c:pt>
                <c:pt idx="9">
                  <c:v>2.8077454897796774</c:v>
                </c:pt>
                <c:pt idx="10">
                  <c:v>2.7173304420902831</c:v>
                </c:pt>
                <c:pt idx="11">
                  <c:v>2.6366081957196754</c:v>
                </c:pt>
                <c:pt idx="12">
                  <c:v>2.620238914505749</c:v>
                </c:pt>
                <c:pt idx="13">
                  <c:v>2.5739845337211276</c:v>
                </c:pt>
                <c:pt idx="14">
                  <c:v>2.5372568279146832</c:v>
                </c:pt>
                <c:pt idx="15">
                  <c:v>2.4640819413284012</c:v>
                </c:pt>
                <c:pt idx="16">
                  <c:v>2.462277541276078</c:v>
                </c:pt>
                <c:pt idx="17">
                  <c:v>2.3301836317449807</c:v>
                </c:pt>
                <c:pt idx="18">
                  <c:v>2.2522787850293424</c:v>
                </c:pt>
                <c:pt idx="19">
                  <c:v>2.13269137533422</c:v>
                </c:pt>
                <c:pt idx="20">
                  <c:v>2.0385018185057051</c:v>
                </c:pt>
                <c:pt idx="21">
                  <c:v>2.0151740408901229</c:v>
                </c:pt>
                <c:pt idx="22">
                  <c:v>1.9995573564998352</c:v>
                </c:pt>
                <c:pt idx="23">
                  <c:v>1.9787916311372276</c:v>
                </c:pt>
                <c:pt idx="24">
                  <c:v>1.9608721185419784</c:v>
                </c:pt>
                <c:pt idx="25">
                  <c:v>1.8993459754253705</c:v>
                </c:pt>
                <c:pt idx="26">
                  <c:v>1.8554536333346314</c:v>
                </c:pt>
                <c:pt idx="27">
                  <c:v>1.8142654636877145</c:v>
                </c:pt>
                <c:pt idx="28">
                  <c:v>1.8062174740851187</c:v>
                </c:pt>
                <c:pt idx="29">
                  <c:v>1.720113582237814</c:v>
                </c:pt>
                <c:pt idx="30">
                  <c:v>1.6998365427206732</c:v>
                </c:pt>
                <c:pt idx="31">
                  <c:v>1.671892935762568</c:v>
                </c:pt>
                <c:pt idx="32">
                  <c:v>1.6612734616748179</c:v>
                </c:pt>
                <c:pt idx="33">
                  <c:v>1.6554766284700215</c:v>
                </c:pt>
                <c:pt idx="34">
                  <c:v>1.6139377442116125</c:v>
                </c:pt>
                <c:pt idx="35">
                  <c:v>1.5816037572035622</c:v>
                </c:pt>
                <c:pt idx="36">
                  <c:v>1.5723247226576802</c:v>
                </c:pt>
                <c:pt idx="37">
                  <c:v>1.5461820901742072</c:v>
                </c:pt>
                <c:pt idx="38">
                  <c:v>1.4732049091812249</c:v>
                </c:pt>
                <c:pt idx="39">
                  <c:v>1.4036604986590633</c:v>
                </c:pt>
                <c:pt idx="40">
                  <c:v>1.3425673040965604</c:v>
                </c:pt>
                <c:pt idx="41">
                  <c:v>1.3152333866302843</c:v>
                </c:pt>
                <c:pt idx="42">
                  <c:v>1.311699884514105</c:v>
                </c:pt>
                <c:pt idx="43">
                  <c:v>1.2901692460501599</c:v>
                </c:pt>
                <c:pt idx="44">
                  <c:v>1.1451158490534838</c:v>
                </c:pt>
                <c:pt idx="45">
                  <c:v>1.1055509926427529</c:v>
                </c:pt>
                <c:pt idx="46">
                  <c:v>0.96431610989218441</c:v>
                </c:pt>
                <c:pt idx="47">
                  <c:v>0.95659542065010772</c:v>
                </c:pt>
                <c:pt idx="48">
                  <c:v>0.89601404777887506</c:v>
                </c:pt>
                <c:pt idx="49">
                  <c:v>0.637330901188171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4-691A-4320-813B-8549DEF2B7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409986056"/>
        <c:axId val="409986448"/>
      </c:barChart>
      <c:catAx>
        <c:axId val="409986056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200" b="1" i="0">
                    <a:solidFill>
                      <a:schemeClr val="tx1"/>
                    </a:solidFill>
                    <a:latin typeface="Arial Narrow"/>
                  </a:defRPr>
                </a:pPr>
                <a:r>
                  <a:rPr lang="ko-KR" altLang="en-US" dirty="0" smtClean="0"/>
                  <a:t>Sample No.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48300740122795138"/>
              <c:y val="0.9052192568778995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16200000" vert="horz"/>
          <a:lstStyle/>
          <a:p>
            <a:pPr>
              <a:defRPr sz="900" b="1" i="0">
                <a:solidFill>
                  <a:schemeClr val="tx1"/>
                </a:solidFill>
                <a:latin typeface="Arial Narrow"/>
              </a:defRPr>
            </a:pPr>
            <a:endParaRPr lang="ja-JP"/>
          </a:p>
        </c:txPr>
        <c:crossAx val="409986448"/>
        <c:crosses val="autoZero"/>
        <c:auto val="1"/>
        <c:lblAlgn val="ctr"/>
        <c:lblOffset val="100"/>
        <c:tickMarkSkip val="1"/>
        <c:noMultiLvlLbl val="0"/>
      </c:catAx>
      <c:valAx>
        <c:axId val="409986448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title>
          <c:tx>
            <c:rich>
              <a:bodyPr rot="16200000" vert="horz"/>
              <a:lstStyle/>
              <a:p>
                <a:pPr>
                  <a:defRPr sz="1200" b="1" i="0">
                    <a:solidFill>
                      <a:schemeClr val="tx1"/>
                    </a:solidFill>
                    <a:latin typeface="Arial Narrow"/>
                  </a:defRPr>
                </a:pPr>
                <a:r>
                  <a:rPr lang="ko-KR" altLang="en-US" dirty="0" smtClean="0"/>
                  <a:t>ILA (μg/ml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2473321519792083E-2"/>
              <c:y val="0.34789305925369268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/>
          <a:lstStyle/>
          <a:p>
            <a:pPr>
              <a:defRPr sz="1100" b="1" i="0">
                <a:solidFill>
                  <a:schemeClr val="tx1"/>
                </a:solidFill>
                <a:latin typeface="Arial Narrow"/>
              </a:defRPr>
            </a:pPr>
            <a:endParaRPr lang="ja-JP"/>
          </a:p>
        </c:txPr>
        <c:crossAx val="409986056"/>
        <c:crosses val="autoZero"/>
        <c:crossBetween val="between"/>
        <c:majorUnit val="1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showDLblsOverMax val="1"/>
  </c:chart>
  <c:spPr>
    <a:solidFill>
      <a:schemeClr val="bg1"/>
    </a:solidFill>
    <a:ln w="254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extLst>
    <c:ext uri="CC8EB2C9-7E31-499d-B8F2-F6CE61031016">
      <ho:hncChartStyle xmlns:ho="http://schemas.haansoft.com/office/8.0" layoutIndex="-1" colorIndex="-1" styleIndex="-1"/>
    </c:ext>
  </c:extLst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810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843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571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961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732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353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111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930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69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90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860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EFBF1-4008-4446-B013-A3BCD20D4BF8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1C820-BDAA-412D-B77E-C22C5A1A65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6402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/>
          <p:cNvGrpSpPr/>
          <p:nvPr/>
        </p:nvGrpSpPr>
        <p:grpSpPr>
          <a:xfrm>
            <a:off x="0" y="0"/>
            <a:ext cx="8784197" cy="6322404"/>
            <a:chOff x="0" y="0"/>
            <a:chExt cx="8784197" cy="6322404"/>
          </a:xfrm>
        </p:grpSpPr>
        <p:graphicFrame>
          <p:nvGraphicFramePr>
            <p:cNvPr id="22" name="グラフ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1583014"/>
                </p:ext>
              </p:extLst>
            </p:nvPr>
          </p:nvGraphicFramePr>
          <p:xfrm>
            <a:off x="1173000" y="3442404"/>
            <a:ext cx="756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5277979"/>
                </p:ext>
              </p:extLst>
            </p:nvPr>
          </p:nvGraphicFramePr>
          <p:xfrm>
            <a:off x="1168237" y="535596"/>
            <a:ext cx="756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正方形/長方形 5"/>
            <p:cNvSpPr/>
            <p:nvPr/>
          </p:nvSpPr>
          <p:spPr>
            <a:xfrm>
              <a:off x="3875809" y="707268"/>
              <a:ext cx="166255" cy="10390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053909" y="605333"/>
              <a:ext cx="9060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longum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8" name="正方形/長方形 7"/>
            <p:cNvSpPr/>
            <p:nvPr/>
          </p:nvSpPr>
          <p:spPr>
            <a:xfrm>
              <a:off x="4971771" y="707268"/>
              <a:ext cx="166255" cy="10390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5149871" y="605333"/>
              <a:ext cx="7665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smtClean="0">
                  <a:latin typeface="Arial Narrow" panose="020B0606020202030204" pitchFamily="34" charset="0"/>
                </a:rPr>
                <a:t>breve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5916428" y="707268"/>
              <a:ext cx="166255" cy="10390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6094528" y="605333"/>
              <a:ext cx="9076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bifidum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7013994" y="707268"/>
              <a:ext cx="166255" cy="103909"/>
            </a:xfrm>
            <a:prstGeom prst="rect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7192094" y="605333"/>
              <a:ext cx="15921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kashiwanohense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 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3875809" y="974853"/>
              <a:ext cx="166255" cy="103909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053909" y="872918"/>
              <a:ext cx="18069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pseudocatenulatum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 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5915678" y="974853"/>
              <a:ext cx="166255" cy="103909"/>
            </a:xfrm>
            <a:prstGeom prst="rect">
              <a:avLst/>
            </a:prstGeom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6093778" y="872918"/>
              <a:ext cx="13083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adolescentis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 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7439204" y="974853"/>
              <a:ext cx="166255" cy="10390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7617304" y="872918"/>
              <a:ext cx="9476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smtClean="0">
                  <a:latin typeface="Arial Narrow" panose="020B0606020202030204" pitchFamily="34" charset="0"/>
                </a:rPr>
                <a:t>B</a:t>
              </a:r>
              <a:r>
                <a:rPr lang="en-US" altLang="ja-JP" sz="1400" b="1" dirty="0" smtClean="0">
                  <a:latin typeface="Arial Narrow" panose="020B0606020202030204" pitchFamily="34" charset="0"/>
                </a:rPr>
                <a:t>. </a:t>
              </a:r>
              <a:r>
                <a:rPr lang="en-US" altLang="ja-JP" sz="1400" b="1" i="1" dirty="0" err="1" smtClean="0">
                  <a:latin typeface="Arial Narrow" panose="020B0606020202030204" pitchFamily="34" charset="0"/>
                </a:rPr>
                <a:t>dentium</a:t>
              </a:r>
              <a:endParaRPr kumimoji="1" lang="ja-JP" altLang="en-US" sz="14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811956" y="605333"/>
              <a:ext cx="3658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Arial Narrow" panose="020B0606020202030204" pitchFamily="34" charset="0"/>
                </a:rPr>
                <a:t>a)</a:t>
              </a:r>
              <a:endParaRPr kumimoji="1" lang="ja-JP" altLang="en-US" b="1" dirty="0">
                <a:latin typeface="Arial Narrow" panose="020B060602020203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811956" y="3599742"/>
              <a:ext cx="3658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Arial Narrow" panose="020B0606020202030204" pitchFamily="34" charset="0"/>
                </a:rPr>
                <a:t>b)</a:t>
              </a:r>
              <a:endParaRPr kumimoji="1" lang="ja-JP" altLang="en-US" b="1" dirty="0">
                <a:latin typeface="Arial Narrow" panose="020B060602020203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0" y="0"/>
              <a:ext cx="13356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>
                  <a:latin typeface="Arial Narrow" panose="020B0606020202030204" pitchFamily="34" charset="0"/>
                </a:rPr>
                <a:t>Figure </a:t>
              </a:r>
              <a:r>
                <a:rPr kumimoji="1" lang="en-US" altLang="ja-JP" sz="2400" b="1" dirty="0" smtClean="0">
                  <a:latin typeface="Arial Narrow" panose="020B0606020202030204" pitchFamily="34" charset="0"/>
                </a:rPr>
                <a:t>S2</a:t>
              </a:r>
              <a:endParaRPr kumimoji="1" lang="ja-JP" altLang="en-US" sz="2400" b="1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22599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41</Words>
  <Application>Microsoft Office PowerPoint</Application>
  <PresentationFormat>A4 210 x 297 mm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Arial Narrow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</dc:creator>
  <cp:lastModifiedBy>森永乳業㈱</cp:lastModifiedBy>
  <cp:revision>10</cp:revision>
  <dcterms:created xsi:type="dcterms:W3CDTF">2018-12-28T02:33:22Z</dcterms:created>
  <dcterms:modified xsi:type="dcterms:W3CDTF">2019-09-11T00:41:22Z</dcterms:modified>
</cp:coreProperties>
</file>